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90" y="3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66548-01EF-43C3-9B52-19D2BC626A36}" type="datetimeFigureOut">
              <a:rPr lang="en-GB" smtClean="0"/>
              <a:t>09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C1DC4F-BD84-44A2-92EF-3F8AA770E2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0998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66548-01EF-43C3-9B52-19D2BC626A36}" type="datetimeFigureOut">
              <a:rPr lang="en-GB" smtClean="0"/>
              <a:t>09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C1DC4F-BD84-44A2-92EF-3F8AA770E2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4830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66548-01EF-43C3-9B52-19D2BC626A36}" type="datetimeFigureOut">
              <a:rPr lang="en-GB" smtClean="0"/>
              <a:t>09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C1DC4F-BD84-44A2-92EF-3F8AA770E2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3118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66548-01EF-43C3-9B52-19D2BC626A36}" type="datetimeFigureOut">
              <a:rPr lang="en-GB" smtClean="0"/>
              <a:t>09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C1DC4F-BD84-44A2-92EF-3F8AA770E2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6313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66548-01EF-43C3-9B52-19D2BC626A36}" type="datetimeFigureOut">
              <a:rPr lang="en-GB" smtClean="0"/>
              <a:t>09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C1DC4F-BD84-44A2-92EF-3F8AA770E2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6299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66548-01EF-43C3-9B52-19D2BC626A36}" type="datetimeFigureOut">
              <a:rPr lang="en-GB" smtClean="0"/>
              <a:t>09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C1DC4F-BD84-44A2-92EF-3F8AA770E2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30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66548-01EF-43C3-9B52-19D2BC626A36}" type="datetimeFigureOut">
              <a:rPr lang="en-GB" smtClean="0"/>
              <a:t>09/10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C1DC4F-BD84-44A2-92EF-3F8AA770E2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065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66548-01EF-43C3-9B52-19D2BC626A36}" type="datetimeFigureOut">
              <a:rPr lang="en-GB" smtClean="0"/>
              <a:t>09/10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C1DC4F-BD84-44A2-92EF-3F8AA770E2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527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66548-01EF-43C3-9B52-19D2BC626A36}" type="datetimeFigureOut">
              <a:rPr lang="en-GB" smtClean="0"/>
              <a:t>09/10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C1DC4F-BD84-44A2-92EF-3F8AA770E2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0213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66548-01EF-43C3-9B52-19D2BC626A36}" type="datetimeFigureOut">
              <a:rPr lang="en-GB" smtClean="0"/>
              <a:t>09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C1DC4F-BD84-44A2-92EF-3F8AA770E2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4280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66548-01EF-43C3-9B52-19D2BC626A36}" type="datetimeFigureOut">
              <a:rPr lang="en-GB" smtClean="0"/>
              <a:t>09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C1DC4F-BD84-44A2-92EF-3F8AA770E2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3620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D66548-01EF-43C3-9B52-19D2BC626A36}" type="datetimeFigureOut">
              <a:rPr lang="en-GB" smtClean="0"/>
              <a:t>09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C1DC4F-BD84-44A2-92EF-3F8AA770E2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6314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3650" y="0"/>
            <a:ext cx="4344699" cy="6858000"/>
          </a:xfrm>
          <a:prstGeom prst="rect">
            <a:avLst/>
          </a:prstGeom>
        </p:spPr>
      </p:pic>
      <p:cxnSp>
        <p:nvCxnSpPr>
          <p:cNvPr id="7" name="Straight Arrow Connector 6"/>
          <p:cNvCxnSpPr/>
          <p:nvPr/>
        </p:nvCxnSpPr>
        <p:spPr>
          <a:xfrm>
            <a:off x="3923650" y="754083"/>
            <a:ext cx="130149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V="1">
            <a:off x="3924657" y="1314450"/>
            <a:ext cx="1568093" cy="17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V="1">
            <a:off x="3923650" y="1849967"/>
            <a:ext cx="2011483" cy="54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V="1">
            <a:off x="3923650" y="2408767"/>
            <a:ext cx="1039933" cy="5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V="1">
            <a:off x="3923650" y="2967568"/>
            <a:ext cx="1541583" cy="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V="1">
            <a:off x="3916189" y="4047067"/>
            <a:ext cx="1549044" cy="478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3923650" y="5164122"/>
            <a:ext cx="1226200" cy="9016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 flipV="1">
            <a:off x="3923650" y="5689600"/>
            <a:ext cx="931983" cy="47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flipV="1">
            <a:off x="3923650" y="6208183"/>
            <a:ext cx="1693983" cy="901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2496730" y="490082"/>
            <a:ext cx="27271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p cap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16350" y="1023867"/>
            <a:ext cx="37923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uminium spacers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401849" y="1593686"/>
            <a:ext cx="37923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irbrush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0" y="2125574"/>
            <a:ext cx="40907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nection to compressor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303646" y="2701178"/>
            <a:ext cx="37923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d plate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357497" y="3776747"/>
            <a:ext cx="37923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lindrical tube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165684" y="4902512"/>
            <a:ext cx="25454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se plate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44351" y="5420538"/>
            <a:ext cx="44177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nection to v. pump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015916" y="5934286"/>
            <a:ext cx="30800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et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0542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36211E7BBA8404699A1A5B224E24945" ma:contentTypeVersion="10" ma:contentTypeDescription="Create a new document." ma:contentTypeScope="" ma:versionID="789ab184d1f338992a1d6baab28ee00c">
  <xsd:schema xmlns:xsd="http://www.w3.org/2001/XMLSchema" xmlns:xs="http://www.w3.org/2001/XMLSchema" xmlns:p="http://schemas.microsoft.com/office/2006/metadata/properties" xmlns:ns3="1882c3a4-113c-4df7-8b40-662890b3e854" xmlns:ns4="087e8e36-ebc0-4f16-b02f-7667ab4b7da2" targetNamespace="http://schemas.microsoft.com/office/2006/metadata/properties" ma:root="true" ma:fieldsID="751b8e5d9af30a173539952384e44032" ns3:_="" ns4:_="">
    <xsd:import namespace="1882c3a4-113c-4df7-8b40-662890b3e854"/>
    <xsd:import namespace="087e8e36-ebc0-4f16-b02f-7667ab4b7da2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DateTaken" minOccurs="0"/>
                <xsd:element ref="ns4:MediaServiceOCR" minOccurs="0"/>
                <xsd:element ref="ns4:MediaServiceGenerationTime" minOccurs="0"/>
                <xsd:element ref="ns4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882c3a4-113c-4df7-8b40-662890b3e854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87e8e36-ebc0-4f16-b02f-7667ab4b7da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BA3C0F8A-631D-4B96-8E9A-6F2B22543DE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882c3a4-113c-4df7-8b40-662890b3e854"/>
    <ds:schemaRef ds:uri="087e8e36-ebc0-4f16-b02f-7667ab4b7da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1E16984-ABFB-46C3-80FE-9B8B5DF3466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A49E541-F4D1-44E9-A802-B37CAB9E5C1E}">
  <ds:schemaRefs>
    <ds:schemaRef ds:uri="http://schemas.microsoft.com/office/2006/metadata/properties"/>
    <ds:schemaRef ds:uri="http://purl.org/dc/terms/"/>
    <ds:schemaRef ds:uri="http://schemas.microsoft.com/office/2006/documentManagement/types"/>
    <ds:schemaRef ds:uri="1882c3a4-113c-4df7-8b40-662890b3e854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087e8e36-ebc0-4f16-b02f-7667ab4b7da2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20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Exe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lswell, Pete</dc:creator>
  <cp:lastModifiedBy>Erdos, Zoltán</cp:lastModifiedBy>
  <cp:revision>3</cp:revision>
  <dcterms:created xsi:type="dcterms:W3CDTF">2019-06-26T14:00:49Z</dcterms:created>
  <dcterms:modified xsi:type="dcterms:W3CDTF">2019-10-09T14:09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36211E7BBA8404699A1A5B224E24945</vt:lpwstr>
  </property>
</Properties>
</file>